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0" d="100"/>
          <a:sy n="50" d="100"/>
        </p:scale>
        <p:origin x="594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17CA8F1-2EA2-400A-A367-B180CC9A9A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76B2EE1-C8F8-4DD5-8395-3B803547C8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BE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C2C2099-AAB2-4BBD-B4DF-BA4A80625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B7D490F-CAFE-4989-8D59-6482E80F0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1D08D82-BD4D-451B-8E75-E6CAE12A1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561257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DB109E-B42F-4A18-BF12-B336F39E1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F0BF0C7-2DE4-40DC-BDD3-C29E0AF27E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BB0184-7B5B-411B-AFC4-6F9C5E858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B52F682-9066-47FC-93A6-E33ABA672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A5BA62E-263E-4863-A342-FB0F574F6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668883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9094566-347B-4C1A-B81F-40AD8B2FB2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409F658-B5CA-4FD5-B51F-731AA3A068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C4BDBF0-BAB2-4EBD-A745-140D4C31E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1AD5710-A7E6-439D-AE84-4270173C9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44541DD-05E5-4CB2-8E95-9D7531CEA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22191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4BD758-1231-40AF-A50D-778AAE74B9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1973C9C-141C-4D88-81C7-1CA3A88ECB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D62984F-4D8B-49E4-A31A-AFF1D602D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80E2C8-5C35-422A-A5CD-6B5696C87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FCD57E5-A62B-44E7-86CB-230AF77FC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053750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54538C-C6E9-4DF8-9786-9802BEB85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1A2580A-9A40-4BE6-9EEF-FF26886EB9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2AEF3B2-DA9E-47ED-8D55-8252541E1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6E273DB-D6B9-4642-9529-C24A7D919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BB9E68A-2118-4837-BE44-5B1E09CBB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36467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8E8C181-DE54-4774-B37B-D74C6BC93C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D136F3F-90C4-4C14-8216-9049C8F7A1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ACF0548-CFD5-4109-8F85-F0603A1261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5F163A6-712D-4240-A15E-388D1FF06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DEDC86A-8A63-42F0-825D-743498FDC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DD42ADC-F08E-49BD-8281-1DE125F74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496363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37EF0AE-69E5-4BC6-89CC-A6E3D183A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7494251-5D30-4C36-83A9-2BA90CB314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92C9730-0367-42C8-94ED-6413C961B7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F7458E1-1439-4E4B-B9B2-66FA7EE75B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DFECE64-088A-4FAC-BF77-21366F8E16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3F56E30-BCD2-4D1E-B74C-E9FAB465C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76B260D-E601-445F-8919-A164372CA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7AB41940-0B9D-47FA-B9CB-9733B1BAF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44244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5D784B-8FCF-4F3E-BA65-8504225F61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18B3268-2A48-4E49-BC62-3A47456FB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9939F24-087B-4E39-8571-E630CD06D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BEF962F-9993-4418-BB5C-18077C626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285835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15EEFB8-AB87-41DA-8A7E-A4186ACD1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329F017-DBD2-4398-847A-CF6E7F035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EE1FA0D-93D0-40F7-B65A-9E00783B5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78214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7049399-47BB-4DB2-B820-C1FCE1790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2331875-B999-4E69-85AA-E4E00C8574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C4D09B3-AD5B-41A7-8CD5-67FCB61701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66A1A9-AE7B-475A-BAE5-35CC93842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7D929A-D7D0-40D0-A3C4-5360C7BD9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7CD215F-6C37-4E93-A6BB-878F3B1EF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125457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48FD7CD-CBF7-461F-B10F-62BD2F467B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19C5E10-3E50-4D3A-9E22-2EC6D7819C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CB6183F-81A5-429E-96F8-C0E6916E9B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7ACAC95-ADD5-4111-9FC2-59950FC1A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FFF08A1-9213-4183-BB66-7F223F211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DE90B92-BBE7-4761-ACFE-A57FC2C92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7728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FF4FBC9-03DE-401E-A789-9B0D69F144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74C99DE-D0B5-4CB4-9DF0-B87FA42D17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854C8C7-CDFB-4EDD-A730-416205ED3C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81C27-C5B4-4A1A-BB9D-8F4119F29EAC}" type="datetimeFigureOut">
              <a:rPr lang="fr-BE" smtClean="0"/>
              <a:t>19-06-24</a:t>
            </a:fld>
            <a:endParaRPr lang="fr-BE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7A4A547-3219-4729-80DD-30FFA93C1C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6BA37F1-241F-43AA-BFA3-F3F806E26C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8478F-2015-4D60-B796-4B1A7D97066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18631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e 80">
            <a:extLst>
              <a:ext uri="{FF2B5EF4-FFF2-40B4-BE49-F238E27FC236}">
                <a16:creationId xmlns:a16="http://schemas.microsoft.com/office/drawing/2014/main" id="{320D8815-3D11-4DFC-A882-D4F9F815D842}"/>
              </a:ext>
            </a:extLst>
          </p:cNvPr>
          <p:cNvGrpSpPr/>
          <p:nvPr/>
        </p:nvGrpSpPr>
        <p:grpSpPr>
          <a:xfrm>
            <a:off x="572106" y="45281"/>
            <a:ext cx="8147226" cy="7123959"/>
            <a:chOff x="572106" y="45281"/>
            <a:chExt cx="8147226" cy="7123959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C5ED1267-05A8-4CD7-A711-4EFC83DDED7F}"/>
                </a:ext>
              </a:extLst>
            </p:cNvPr>
            <p:cNvSpPr txBox="1"/>
            <p:nvPr/>
          </p:nvSpPr>
          <p:spPr>
            <a:xfrm>
              <a:off x="5674841" y="2593038"/>
              <a:ext cx="304449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1200" dirty="0">
                  <a:latin typeface="Arial" panose="020B0604020202020204" pitchFamily="34" charset="0"/>
                  <a:cs typeface="Arial" panose="020B0604020202020204" pitchFamily="34" charset="0"/>
                </a:rPr>
                <a:t>IP: G3BP1 (PT13057-2-AP)</a:t>
              </a:r>
            </a:p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fr-BE" sz="1200" dirty="0">
                  <a:latin typeface="Arial" panose="020B0604020202020204" pitchFamily="34" charset="0"/>
                  <a:cs typeface="Arial" panose="020B0604020202020204" pitchFamily="34" charset="0"/>
                </a:rPr>
                <a:t>B: G3BP1 (PT13057-2-AP)</a:t>
              </a:r>
            </a:p>
            <a:p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12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fr-BE" sz="1200" i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pped</a:t>
              </a:r>
              <a:r>
                <a:rPr lang="fr-BE" sz="12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rea</a:t>
              </a:r>
            </a:p>
          </p:txBody>
        </p:sp>
        <p:cxnSp>
          <p:nvCxnSpPr>
            <p:cNvPr id="6" name="Connecteur droit 5">
              <a:extLst>
                <a:ext uri="{FF2B5EF4-FFF2-40B4-BE49-F238E27FC236}">
                  <a16:creationId xmlns:a16="http://schemas.microsoft.com/office/drawing/2014/main" id="{2FDC9A94-3762-4085-8673-ED2C8EE3559B}"/>
                </a:ext>
              </a:extLst>
            </p:cNvPr>
            <p:cNvCxnSpPr/>
            <p:nvPr/>
          </p:nvCxnSpPr>
          <p:spPr>
            <a:xfrm>
              <a:off x="2042055" y="702296"/>
              <a:ext cx="1512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636AA84D-29F8-4432-B1B6-BB70C9196829}"/>
                </a:ext>
              </a:extLst>
            </p:cNvPr>
            <p:cNvCxnSpPr/>
            <p:nvPr/>
          </p:nvCxnSpPr>
          <p:spPr>
            <a:xfrm>
              <a:off x="3960862" y="702296"/>
              <a:ext cx="1512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5B59C189-F208-4704-A91A-2AF083728EF6}"/>
                </a:ext>
              </a:extLst>
            </p:cNvPr>
            <p:cNvSpPr txBox="1"/>
            <p:nvPr/>
          </p:nvSpPr>
          <p:spPr>
            <a:xfrm>
              <a:off x="1774841" y="429268"/>
              <a:ext cx="1956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fr-B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F8F68B6B-5979-44EB-813A-E2106897FC39}"/>
                </a:ext>
              </a:extLst>
            </p:cNvPr>
            <p:cNvSpPr txBox="1"/>
            <p:nvPr/>
          </p:nvSpPr>
          <p:spPr>
            <a:xfrm>
              <a:off x="3974384" y="404296"/>
              <a:ext cx="1512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SP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osslinked</a:t>
              </a:r>
              <a:endParaRPr lang="fr-B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0C3CB415-19AA-4C13-8C3C-6B32EA5F2432}"/>
                </a:ext>
              </a:extLst>
            </p:cNvPr>
            <p:cNvSpPr txBox="1"/>
            <p:nvPr/>
          </p:nvSpPr>
          <p:spPr>
            <a:xfrm rot="16200000">
              <a:off x="1537015" y="1020924"/>
              <a:ext cx="12162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65C4380-E0FA-4C61-9C85-9CDB2E7D3DAF}"/>
                </a:ext>
              </a:extLst>
            </p:cNvPr>
            <p:cNvSpPr txBox="1"/>
            <p:nvPr/>
          </p:nvSpPr>
          <p:spPr>
            <a:xfrm rot="16200000">
              <a:off x="1922024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Flowthrough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40391BA4-1CBA-4EAA-BC74-99FE739A8D5C}"/>
                </a:ext>
              </a:extLst>
            </p:cNvPr>
            <p:cNvSpPr txBox="1"/>
            <p:nvPr/>
          </p:nvSpPr>
          <p:spPr>
            <a:xfrm rot="16200000">
              <a:off x="2335910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IP: IgG control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15BB7520-C52D-4B63-AFE4-C930069DB3A5}"/>
                </a:ext>
              </a:extLst>
            </p:cNvPr>
            <p:cNvSpPr txBox="1"/>
            <p:nvPr/>
          </p:nvSpPr>
          <p:spPr>
            <a:xfrm rot="16200000">
              <a:off x="2749797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IP: G3BP1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18C4463F-44DA-44D5-BAD0-712F28B70377}"/>
                </a:ext>
              </a:extLst>
            </p:cNvPr>
            <p:cNvSpPr txBox="1"/>
            <p:nvPr/>
          </p:nvSpPr>
          <p:spPr>
            <a:xfrm rot="16200000">
              <a:off x="3537318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BEB97633-45D1-444C-BF6E-DDEF782644D8}"/>
                </a:ext>
              </a:extLst>
            </p:cNvPr>
            <p:cNvSpPr txBox="1"/>
            <p:nvPr/>
          </p:nvSpPr>
          <p:spPr>
            <a:xfrm rot="16200000">
              <a:off x="3922328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Flowthrough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D0A7EABE-3828-46B4-8211-0CBBB92551E8}"/>
                </a:ext>
              </a:extLst>
            </p:cNvPr>
            <p:cNvSpPr txBox="1"/>
            <p:nvPr/>
          </p:nvSpPr>
          <p:spPr>
            <a:xfrm rot="16200000">
              <a:off x="4336214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IP: IgG control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B192EDA9-E1CD-499E-8EB1-B3BA8656D066}"/>
                </a:ext>
              </a:extLst>
            </p:cNvPr>
            <p:cNvSpPr txBox="1"/>
            <p:nvPr/>
          </p:nvSpPr>
          <p:spPr>
            <a:xfrm rot="16200000">
              <a:off x="4750101" y="1020923"/>
              <a:ext cx="12162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IP: G3BP1</a:t>
              </a:r>
            </a:p>
          </p:txBody>
        </p:sp>
        <p:grpSp>
          <p:nvGrpSpPr>
            <p:cNvPr id="19" name="Groupe 18">
              <a:extLst>
                <a:ext uri="{FF2B5EF4-FFF2-40B4-BE49-F238E27FC236}">
                  <a16:creationId xmlns:a16="http://schemas.microsoft.com/office/drawing/2014/main" id="{E2281612-38E3-47D8-B532-62EE87905B0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2106" y="1870487"/>
              <a:ext cx="4982981" cy="1985870"/>
              <a:chOff x="656809" y="2496193"/>
              <a:chExt cx="3193961" cy="1272893"/>
            </a:xfrm>
          </p:grpSpPr>
          <p:grpSp>
            <p:nvGrpSpPr>
              <p:cNvPr id="23" name="Groupe 22">
                <a:extLst>
                  <a:ext uri="{FF2B5EF4-FFF2-40B4-BE49-F238E27FC236}">
                    <a16:creationId xmlns:a16="http://schemas.microsoft.com/office/drawing/2014/main" id="{330E797E-A6B1-4902-94D6-D6589973AC4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56809" y="2496193"/>
                <a:ext cx="969093" cy="1224522"/>
                <a:chOff x="4472387" y="3029990"/>
                <a:chExt cx="590204" cy="1017232"/>
              </a:xfrm>
            </p:grpSpPr>
            <p:grpSp>
              <p:nvGrpSpPr>
                <p:cNvPr id="25" name="Groupe 24">
                  <a:extLst>
                    <a:ext uri="{FF2B5EF4-FFF2-40B4-BE49-F238E27FC236}">
                      <a16:creationId xmlns:a16="http://schemas.microsoft.com/office/drawing/2014/main" id="{7E4CF19F-A8EF-439C-8694-2F399EF7C3B8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4472387" y="3029990"/>
                  <a:ext cx="590204" cy="776581"/>
                  <a:chOff x="2570418" y="4583561"/>
                  <a:chExt cx="236057" cy="310600"/>
                </a:xfrm>
              </p:grpSpPr>
              <p:sp>
                <p:nvSpPr>
                  <p:cNvPr id="28" name="ZoneTexte 27">
                    <a:extLst>
                      <a:ext uri="{FF2B5EF4-FFF2-40B4-BE49-F238E27FC236}">
                        <a16:creationId xmlns:a16="http://schemas.microsoft.com/office/drawing/2014/main" id="{41E0D7EF-E362-4F11-B574-5A8CBB966092}"/>
                      </a:ext>
                    </a:extLst>
                  </p:cNvPr>
                  <p:cNvSpPr txBox="1"/>
                  <p:nvPr/>
                </p:nvSpPr>
                <p:spPr>
                  <a:xfrm>
                    <a:off x="2596327" y="4583561"/>
                    <a:ext cx="153356" cy="458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kDa</a:t>
                    </a:r>
                  </a:p>
                </p:txBody>
              </p:sp>
              <p:cxnSp>
                <p:nvCxnSpPr>
                  <p:cNvPr id="29" name="Connecteur droit 28">
                    <a:extLst>
                      <a:ext uri="{FF2B5EF4-FFF2-40B4-BE49-F238E27FC236}">
                        <a16:creationId xmlns:a16="http://schemas.microsoft.com/office/drawing/2014/main" id="{4CA5A920-8198-49EC-9F40-2744AD2634B5}"/>
                      </a:ext>
                    </a:extLst>
                  </p:cNvPr>
                  <p:cNvCxnSpPr/>
                  <p:nvPr/>
                </p:nvCxnSpPr>
                <p:spPr>
                  <a:xfrm>
                    <a:off x="2748881" y="4607904"/>
                    <a:ext cx="57594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" name="ZoneTexte 29">
                    <a:extLst>
                      <a:ext uri="{FF2B5EF4-FFF2-40B4-BE49-F238E27FC236}">
                        <a16:creationId xmlns:a16="http://schemas.microsoft.com/office/drawing/2014/main" id="{D60DB42A-FAF7-486A-A284-4C1A1E1EBF5D}"/>
                      </a:ext>
                    </a:extLst>
                  </p:cNvPr>
                  <p:cNvSpPr txBox="1"/>
                  <p:nvPr/>
                </p:nvSpPr>
                <p:spPr>
                  <a:xfrm>
                    <a:off x="2570418" y="4678584"/>
                    <a:ext cx="181656" cy="458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0kDa</a:t>
                    </a:r>
                  </a:p>
                </p:txBody>
              </p:sp>
              <p:cxnSp>
                <p:nvCxnSpPr>
                  <p:cNvPr id="31" name="Connecteur droit 30">
                    <a:extLst>
                      <a:ext uri="{FF2B5EF4-FFF2-40B4-BE49-F238E27FC236}">
                        <a16:creationId xmlns:a16="http://schemas.microsoft.com/office/drawing/2014/main" id="{394EEEB9-9F6B-4137-A6D2-FA040D578511}"/>
                      </a:ext>
                    </a:extLst>
                  </p:cNvPr>
                  <p:cNvCxnSpPr/>
                  <p:nvPr/>
                </p:nvCxnSpPr>
                <p:spPr>
                  <a:xfrm>
                    <a:off x="2748881" y="4702903"/>
                    <a:ext cx="57594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" name="ZoneTexte 31">
                    <a:extLst>
                      <a:ext uri="{FF2B5EF4-FFF2-40B4-BE49-F238E27FC236}">
                        <a16:creationId xmlns:a16="http://schemas.microsoft.com/office/drawing/2014/main" id="{62C717BE-C013-4F0E-9629-E2CAED809B2E}"/>
                      </a:ext>
                    </a:extLst>
                  </p:cNvPr>
                  <p:cNvSpPr txBox="1"/>
                  <p:nvPr/>
                </p:nvSpPr>
                <p:spPr>
                  <a:xfrm>
                    <a:off x="2620688" y="4768139"/>
                    <a:ext cx="133016" cy="458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5kDa</a:t>
                    </a:r>
                  </a:p>
                </p:txBody>
              </p:sp>
              <p:cxnSp>
                <p:nvCxnSpPr>
                  <p:cNvPr id="33" name="Connecteur droit 32">
                    <a:extLst>
                      <a:ext uri="{FF2B5EF4-FFF2-40B4-BE49-F238E27FC236}">
                        <a16:creationId xmlns:a16="http://schemas.microsoft.com/office/drawing/2014/main" id="{F661F9E9-2CA0-45DC-B13B-4665C061126D}"/>
                      </a:ext>
                    </a:extLst>
                  </p:cNvPr>
                  <p:cNvCxnSpPr/>
                  <p:nvPr/>
                </p:nvCxnSpPr>
                <p:spPr>
                  <a:xfrm>
                    <a:off x="2748881" y="4791085"/>
                    <a:ext cx="57594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" name="ZoneTexte 33">
                    <a:extLst>
                      <a:ext uri="{FF2B5EF4-FFF2-40B4-BE49-F238E27FC236}">
                        <a16:creationId xmlns:a16="http://schemas.microsoft.com/office/drawing/2014/main" id="{325C5A5E-87CD-424D-BF0A-D4D43476D3BA}"/>
                      </a:ext>
                    </a:extLst>
                  </p:cNvPr>
                  <p:cNvSpPr txBox="1"/>
                  <p:nvPr/>
                </p:nvSpPr>
                <p:spPr>
                  <a:xfrm>
                    <a:off x="2597487" y="4848279"/>
                    <a:ext cx="156475" cy="458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2kDa</a:t>
                    </a:r>
                  </a:p>
                </p:txBody>
              </p:sp>
              <p:cxnSp>
                <p:nvCxnSpPr>
                  <p:cNvPr id="35" name="Connecteur droit 34">
                    <a:extLst>
                      <a:ext uri="{FF2B5EF4-FFF2-40B4-BE49-F238E27FC236}">
                        <a16:creationId xmlns:a16="http://schemas.microsoft.com/office/drawing/2014/main" id="{52B1E076-3840-4499-A78E-948F68F266BC}"/>
                      </a:ext>
                    </a:extLst>
                  </p:cNvPr>
                  <p:cNvCxnSpPr/>
                  <p:nvPr/>
                </p:nvCxnSpPr>
                <p:spPr>
                  <a:xfrm>
                    <a:off x="2748881" y="4874627"/>
                    <a:ext cx="57594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6" name="ZoneTexte 25">
                  <a:extLst>
                    <a:ext uri="{FF2B5EF4-FFF2-40B4-BE49-F238E27FC236}">
                      <a16:creationId xmlns:a16="http://schemas.microsoft.com/office/drawing/2014/main" id="{5EE771FB-C4AB-4800-91B6-863682389B18}"/>
                    </a:ext>
                  </a:extLst>
                </p:cNvPr>
                <p:cNvSpPr txBox="1"/>
                <p:nvPr/>
              </p:nvSpPr>
              <p:spPr>
                <a:xfrm>
                  <a:off x="4639539" y="3932505"/>
                  <a:ext cx="291882" cy="1147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kDa</a:t>
                  </a:r>
                </a:p>
              </p:txBody>
            </p:sp>
            <p:cxnSp>
              <p:nvCxnSpPr>
                <p:cNvPr id="27" name="Connecteur droit 26">
                  <a:extLst>
                    <a:ext uri="{FF2B5EF4-FFF2-40B4-BE49-F238E27FC236}">
                      <a16:creationId xmlns:a16="http://schemas.microsoft.com/office/drawing/2014/main" id="{585021B7-5F25-4495-AE9D-CA1CF0582A13}"/>
                    </a:ext>
                  </a:extLst>
                </p:cNvPr>
                <p:cNvCxnSpPr/>
                <p:nvPr/>
              </p:nvCxnSpPr>
              <p:spPr>
                <a:xfrm>
                  <a:off x="4917483" y="3993811"/>
                  <a:ext cx="144000" cy="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4" name="Image 23">
                <a:extLst>
                  <a:ext uri="{FF2B5EF4-FFF2-40B4-BE49-F238E27FC236}">
                    <a16:creationId xmlns:a16="http://schemas.microsoft.com/office/drawing/2014/main" id="{C9BCF259-71C1-44DC-A83A-36AD51BE22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206" t="31764" r="11776" b="27453"/>
              <a:stretch/>
            </p:blipFill>
            <p:spPr>
              <a:xfrm>
                <a:off x="1478138" y="2496193"/>
                <a:ext cx="2372632" cy="127289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20" name="Groupe 19">
              <a:extLst>
                <a:ext uri="{FF2B5EF4-FFF2-40B4-BE49-F238E27FC236}">
                  <a16:creationId xmlns:a16="http://schemas.microsoft.com/office/drawing/2014/main" id="{A331E671-865D-4A88-BB43-AD2EA3287CDA}"/>
                </a:ext>
              </a:extLst>
            </p:cNvPr>
            <p:cNvGrpSpPr/>
            <p:nvPr/>
          </p:nvGrpSpPr>
          <p:grpSpPr>
            <a:xfrm>
              <a:off x="2042055" y="45281"/>
              <a:ext cx="3430808" cy="307777"/>
              <a:chOff x="780677" y="997121"/>
              <a:chExt cx="3729578" cy="307777"/>
            </a:xfrm>
          </p:grpSpPr>
          <p:cxnSp>
            <p:nvCxnSpPr>
              <p:cNvPr id="21" name="Connecteur droit 20">
                <a:extLst>
                  <a:ext uri="{FF2B5EF4-FFF2-40B4-BE49-F238E27FC236}">
                    <a16:creationId xmlns:a16="http://schemas.microsoft.com/office/drawing/2014/main" id="{62195413-3F00-411C-B7B9-7C27B845CA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0677" y="1295121"/>
                <a:ext cx="371605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FC891A4B-2F3D-4F0B-9FDC-80A246F63AC1}"/>
                  </a:ext>
                </a:extLst>
              </p:cNvPr>
              <p:cNvSpPr txBox="1"/>
              <p:nvPr/>
            </p:nvSpPr>
            <p:spPr>
              <a:xfrm>
                <a:off x="794198" y="997121"/>
                <a:ext cx="37160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La </a:t>
                </a:r>
                <a:r>
                  <a:rPr lang="fr-FR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fr-BE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7619D8F8-B784-461F-8794-7C30B32DD4D0}"/>
                </a:ext>
              </a:extLst>
            </p:cNvPr>
            <p:cNvSpPr/>
            <p:nvPr/>
          </p:nvSpPr>
          <p:spPr>
            <a:xfrm>
              <a:off x="4757581" y="2747797"/>
              <a:ext cx="733567" cy="9371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FD1D6FC4-E1C1-4234-9F40-EBE123AD6D50}"/>
                </a:ext>
              </a:extLst>
            </p:cNvPr>
            <p:cNvSpPr/>
            <p:nvPr/>
          </p:nvSpPr>
          <p:spPr>
            <a:xfrm>
              <a:off x="3937000" y="2745412"/>
              <a:ext cx="423864" cy="9371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0" name="Groupe 79">
              <a:extLst>
                <a:ext uri="{FF2B5EF4-FFF2-40B4-BE49-F238E27FC236}">
                  <a16:creationId xmlns:a16="http://schemas.microsoft.com/office/drawing/2014/main" id="{F3BADBDC-E1E3-46BE-86D4-28EAD5630278}"/>
                </a:ext>
              </a:extLst>
            </p:cNvPr>
            <p:cNvGrpSpPr/>
            <p:nvPr/>
          </p:nvGrpSpPr>
          <p:grpSpPr>
            <a:xfrm>
              <a:off x="699431" y="3923318"/>
              <a:ext cx="4855656" cy="3245922"/>
              <a:chOff x="1472940" y="4219569"/>
              <a:chExt cx="5063997" cy="3385191"/>
            </a:xfrm>
          </p:grpSpPr>
          <p:pic>
            <p:nvPicPr>
              <p:cNvPr id="65" name="Image 64">
                <a:extLst>
                  <a:ext uri="{FF2B5EF4-FFF2-40B4-BE49-F238E27FC236}">
                    <a16:creationId xmlns:a16="http://schemas.microsoft.com/office/drawing/2014/main" id="{24359062-4FCA-4D1D-AABB-2463B319ED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42" t="7884" r="12078" b="21828"/>
              <a:stretch/>
            </p:blipFill>
            <p:spPr>
              <a:xfrm>
                <a:off x="2665728" y="4219569"/>
                <a:ext cx="3871209" cy="338519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67" name="Groupe 66">
                <a:extLst>
                  <a:ext uri="{FF2B5EF4-FFF2-40B4-BE49-F238E27FC236}">
                    <a16:creationId xmlns:a16="http://schemas.microsoft.com/office/drawing/2014/main" id="{CE66A842-C67D-4AF9-8ACB-FE39C066FAD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472940" y="5376609"/>
                <a:ext cx="1189183" cy="1914748"/>
                <a:chOff x="4539397" y="3026155"/>
                <a:chExt cx="464224" cy="1019541"/>
              </a:xfrm>
            </p:grpSpPr>
            <p:grpSp>
              <p:nvGrpSpPr>
                <p:cNvPr id="69" name="Groupe 68">
                  <a:extLst>
                    <a:ext uri="{FF2B5EF4-FFF2-40B4-BE49-F238E27FC236}">
                      <a16:creationId xmlns:a16="http://schemas.microsoft.com/office/drawing/2014/main" id="{10C57086-CAE5-4803-87BC-3FA6420A173D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4539397" y="3026155"/>
                  <a:ext cx="464224" cy="789015"/>
                  <a:chOff x="2597218" y="4582042"/>
                  <a:chExt cx="185670" cy="315574"/>
                </a:xfrm>
              </p:grpSpPr>
              <p:sp>
                <p:nvSpPr>
                  <p:cNvPr id="72" name="ZoneTexte 71">
                    <a:extLst>
                      <a:ext uri="{FF2B5EF4-FFF2-40B4-BE49-F238E27FC236}">
                        <a16:creationId xmlns:a16="http://schemas.microsoft.com/office/drawing/2014/main" id="{D9978625-E193-4233-8303-A2E4835B97AF}"/>
                      </a:ext>
                    </a:extLst>
                  </p:cNvPr>
                  <p:cNvSpPr txBox="1"/>
                  <p:nvPr/>
                </p:nvSpPr>
                <p:spPr>
                  <a:xfrm>
                    <a:off x="2623128" y="4582042"/>
                    <a:ext cx="153356" cy="478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kDa</a:t>
                    </a:r>
                  </a:p>
                </p:txBody>
              </p:sp>
              <p:cxnSp>
                <p:nvCxnSpPr>
                  <p:cNvPr id="73" name="Connecteur droit 72">
                    <a:extLst>
                      <a:ext uri="{FF2B5EF4-FFF2-40B4-BE49-F238E27FC236}">
                        <a16:creationId xmlns:a16="http://schemas.microsoft.com/office/drawing/2014/main" id="{C5888D13-3A29-41A6-A3A6-4C3499806207}"/>
                      </a:ext>
                    </a:extLst>
                  </p:cNvPr>
                  <p:cNvCxnSpPr/>
                  <p:nvPr/>
                </p:nvCxnSpPr>
                <p:spPr>
                  <a:xfrm>
                    <a:off x="2765995" y="4607904"/>
                    <a:ext cx="16881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4" name="ZoneTexte 73">
                    <a:extLst>
                      <a:ext uri="{FF2B5EF4-FFF2-40B4-BE49-F238E27FC236}">
                        <a16:creationId xmlns:a16="http://schemas.microsoft.com/office/drawing/2014/main" id="{35B13F2D-85B4-41D2-B2B7-8591196DD7FD}"/>
                      </a:ext>
                    </a:extLst>
                  </p:cNvPr>
                  <p:cNvSpPr txBox="1"/>
                  <p:nvPr/>
                </p:nvSpPr>
                <p:spPr>
                  <a:xfrm>
                    <a:off x="2597218" y="4678036"/>
                    <a:ext cx="181656" cy="478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0kDa</a:t>
                    </a:r>
                  </a:p>
                </p:txBody>
              </p:sp>
              <p:cxnSp>
                <p:nvCxnSpPr>
                  <p:cNvPr id="75" name="Connecteur droit 74">
                    <a:extLst>
                      <a:ext uri="{FF2B5EF4-FFF2-40B4-BE49-F238E27FC236}">
                        <a16:creationId xmlns:a16="http://schemas.microsoft.com/office/drawing/2014/main" id="{7FFA52AB-4AE9-4F4C-AEBA-E66B96531EC4}"/>
                      </a:ext>
                    </a:extLst>
                  </p:cNvPr>
                  <p:cNvCxnSpPr/>
                  <p:nvPr/>
                </p:nvCxnSpPr>
                <p:spPr>
                  <a:xfrm>
                    <a:off x="2765995" y="4702903"/>
                    <a:ext cx="16881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6" name="ZoneTexte 75">
                    <a:extLst>
                      <a:ext uri="{FF2B5EF4-FFF2-40B4-BE49-F238E27FC236}">
                        <a16:creationId xmlns:a16="http://schemas.microsoft.com/office/drawing/2014/main" id="{4745A120-2BDD-47E4-AB70-D3888BCC49C1}"/>
                      </a:ext>
                    </a:extLst>
                  </p:cNvPr>
                  <p:cNvSpPr txBox="1"/>
                  <p:nvPr/>
                </p:nvSpPr>
                <p:spPr>
                  <a:xfrm>
                    <a:off x="2645940" y="4763401"/>
                    <a:ext cx="133016" cy="478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5kDa</a:t>
                    </a:r>
                  </a:p>
                </p:txBody>
              </p:sp>
              <p:cxnSp>
                <p:nvCxnSpPr>
                  <p:cNvPr id="77" name="Connecteur droit 76">
                    <a:extLst>
                      <a:ext uri="{FF2B5EF4-FFF2-40B4-BE49-F238E27FC236}">
                        <a16:creationId xmlns:a16="http://schemas.microsoft.com/office/drawing/2014/main" id="{939C91E3-0260-4294-8134-C4E8E14B8CDE}"/>
                      </a:ext>
                    </a:extLst>
                  </p:cNvPr>
                  <p:cNvCxnSpPr/>
                  <p:nvPr/>
                </p:nvCxnSpPr>
                <p:spPr>
                  <a:xfrm>
                    <a:off x="2765999" y="4791085"/>
                    <a:ext cx="16881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8" name="ZoneTexte 77">
                    <a:extLst>
                      <a:ext uri="{FF2B5EF4-FFF2-40B4-BE49-F238E27FC236}">
                        <a16:creationId xmlns:a16="http://schemas.microsoft.com/office/drawing/2014/main" id="{1D1B8FF5-03E4-4E2B-9920-E39C87DE7AA7}"/>
                      </a:ext>
                    </a:extLst>
                  </p:cNvPr>
                  <p:cNvSpPr txBox="1"/>
                  <p:nvPr/>
                </p:nvSpPr>
                <p:spPr>
                  <a:xfrm>
                    <a:off x="2621964" y="4849765"/>
                    <a:ext cx="156475" cy="478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fr-B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2kDa</a:t>
                    </a:r>
                  </a:p>
                </p:txBody>
              </p:sp>
              <p:cxnSp>
                <p:nvCxnSpPr>
                  <p:cNvPr id="79" name="Connecteur droit 78">
                    <a:extLst>
                      <a:ext uri="{FF2B5EF4-FFF2-40B4-BE49-F238E27FC236}">
                        <a16:creationId xmlns:a16="http://schemas.microsoft.com/office/drawing/2014/main" id="{A0793EEA-E588-4157-8099-0F101C80D5F3}"/>
                      </a:ext>
                    </a:extLst>
                  </p:cNvPr>
                  <p:cNvCxnSpPr/>
                  <p:nvPr/>
                </p:nvCxnSpPr>
                <p:spPr>
                  <a:xfrm>
                    <a:off x="2766007" y="4874627"/>
                    <a:ext cx="16881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0" name="ZoneTexte 69">
                  <a:extLst>
                    <a:ext uri="{FF2B5EF4-FFF2-40B4-BE49-F238E27FC236}">
                      <a16:creationId xmlns:a16="http://schemas.microsoft.com/office/drawing/2014/main" id="{54FC5B0B-0ED5-460D-BBA0-E05847FA50A4}"/>
                    </a:ext>
                  </a:extLst>
                </p:cNvPr>
                <p:cNvSpPr txBox="1"/>
                <p:nvPr/>
              </p:nvSpPr>
              <p:spPr>
                <a:xfrm>
                  <a:off x="4700730" y="3926057"/>
                  <a:ext cx="291882" cy="1196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kDa</a:t>
                  </a:r>
                </a:p>
              </p:txBody>
            </p:sp>
            <p:cxnSp>
              <p:nvCxnSpPr>
                <p:cNvPr id="71" name="Connecteur droit 70">
                  <a:extLst>
                    <a:ext uri="{FF2B5EF4-FFF2-40B4-BE49-F238E27FC236}">
                      <a16:creationId xmlns:a16="http://schemas.microsoft.com/office/drawing/2014/main" id="{0E56BEF2-D3E6-4849-BD6E-21179714B303}"/>
                    </a:ext>
                  </a:extLst>
                </p:cNvPr>
                <p:cNvCxnSpPr/>
                <p:nvPr/>
              </p:nvCxnSpPr>
              <p:spPr>
                <a:xfrm>
                  <a:off x="4960299" y="3993811"/>
                  <a:ext cx="42207" cy="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27903451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8</Words>
  <Application>Microsoft Office PowerPoint</Application>
  <PresentationFormat>Grand écran</PresentationFormat>
  <Paragraphs>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xime Libert</dc:creator>
  <cp:lastModifiedBy>Maxime Libert</cp:lastModifiedBy>
  <cp:revision>7</cp:revision>
  <dcterms:created xsi:type="dcterms:W3CDTF">2024-06-14T14:46:36Z</dcterms:created>
  <dcterms:modified xsi:type="dcterms:W3CDTF">2024-06-19T10:21:18Z</dcterms:modified>
</cp:coreProperties>
</file>